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-708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611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955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401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103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053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865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204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265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930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230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791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BC248-963A-4C87-9809-988B989DD4A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F0222-B1AF-4DF0-8520-CE47751C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129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44699" y="4327301"/>
            <a:ext cx="117326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ion of growth of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pestris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pestris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CC 33913 by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</a:t>
            </a:r>
            <a:r>
              <a:rPr lang="en-US" sz="16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dwigii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K17 and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putida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M17. 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2678806" y="746974"/>
            <a:ext cx="5960041" cy="3236301"/>
            <a:chOff x="1854558" y="978794"/>
            <a:chExt cx="5960041" cy="323630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51" t="7324" r="10772" b="31268"/>
            <a:stretch/>
          </p:blipFill>
          <p:spPr>
            <a:xfrm>
              <a:off x="1854558" y="978795"/>
              <a:ext cx="2880023" cy="2897746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4" t="9770" r="33145" b="4095"/>
            <a:stretch/>
          </p:blipFill>
          <p:spPr>
            <a:xfrm rot="5400000">
              <a:off x="4937609" y="999552"/>
              <a:ext cx="2897747" cy="2856232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2304554" y="3876541"/>
              <a:ext cx="178125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</a:t>
              </a:r>
              <a:r>
                <a:rPr lang="en-US" sz="16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dwigii</a:t>
              </a:r>
              <a:r>
                <a:rPr lang="en-US" sz="16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K17 </a:t>
              </a:r>
              <a:endParaRPr lang="en-US" sz="1600" dirty="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5736098" y="3876541"/>
              <a:ext cx="164096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. putida 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M17 </a:t>
              </a:r>
              <a:endParaRPr 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25311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5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jurul</dc:creator>
  <cp:lastModifiedBy>Dr. Md. Manju</cp:lastModifiedBy>
  <cp:revision>3</cp:revision>
  <dcterms:created xsi:type="dcterms:W3CDTF">2021-03-09T09:28:01Z</dcterms:created>
  <dcterms:modified xsi:type="dcterms:W3CDTF">2021-10-03T08:16:38Z</dcterms:modified>
</cp:coreProperties>
</file>